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58" r:id="rId2"/>
    <p:sldId id="256" r:id="rId3"/>
    <p:sldId id="257" r:id="rId4"/>
    <p:sldId id="259" r:id="rId5"/>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92" d="100"/>
          <a:sy n="92" d="100"/>
        </p:scale>
        <p:origin x="307" y="8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stacked"/>
        <c:varyColors val="0"/>
        <c:ser>
          <c:idx val="4"/>
          <c:order val="4"/>
          <c:tx>
            <c:strRef>
              <c:f>Sheet1!$F$1</c:f>
              <c:strCache>
                <c:ptCount val="1"/>
                <c:pt idx="0">
                  <c:v>Sequencing depth</c:v>
                </c:pt>
              </c:strCache>
            </c:strRef>
          </c:tx>
          <c:spPr>
            <a:solidFill>
              <a:srgbClr val="00B050"/>
            </a:solidFill>
            <a:ln>
              <a:solidFill>
                <a:srgbClr val="00B050"/>
              </a:solidFill>
            </a:ln>
            <a:effectLst/>
          </c:spPr>
          <c:invertIfNegative val="0"/>
          <c:cat>
            <c:strRef>
              <c:f>Sheet1!$A$2:$A$29</c:f>
              <c:strCache>
                <c:ptCount val="28"/>
                <c:pt idx="0">
                  <c:v>124446BX</c:v>
                </c:pt>
                <c:pt idx="1">
                  <c:v>125670BX</c:v>
                </c:pt>
                <c:pt idx="2">
                  <c:v>125671BX</c:v>
                </c:pt>
                <c:pt idx="3">
                  <c:v>125672BX</c:v>
                </c:pt>
                <c:pt idx="4">
                  <c:v>125674BX</c:v>
                </c:pt>
                <c:pt idx="5">
                  <c:v>125675BX</c:v>
                </c:pt>
                <c:pt idx="6">
                  <c:v>126321BX</c:v>
                </c:pt>
                <c:pt idx="7">
                  <c:v>126322BX</c:v>
                </c:pt>
                <c:pt idx="8">
                  <c:v>126323BX</c:v>
                </c:pt>
                <c:pt idx="9">
                  <c:v>127395BX</c:v>
                </c:pt>
                <c:pt idx="10">
                  <c:v>129442BX</c:v>
                </c:pt>
                <c:pt idx="11">
                  <c:v>129444BX</c:v>
                </c:pt>
                <c:pt idx="12">
                  <c:v>129445BX</c:v>
                </c:pt>
                <c:pt idx="13">
                  <c:v>129446BX</c:v>
                </c:pt>
                <c:pt idx="14">
                  <c:v>129447BX</c:v>
                </c:pt>
                <c:pt idx="15">
                  <c:v>129453BX</c:v>
                </c:pt>
                <c:pt idx="16">
                  <c:v>129454BX</c:v>
                </c:pt>
                <c:pt idx="17">
                  <c:v>129455BX</c:v>
                </c:pt>
                <c:pt idx="18">
                  <c:v>129457BX</c:v>
                </c:pt>
                <c:pt idx="19">
                  <c:v>129460BX</c:v>
                </c:pt>
                <c:pt idx="20">
                  <c:v>129465BX</c:v>
                </c:pt>
                <c:pt idx="21">
                  <c:v>130152BX</c:v>
                </c:pt>
                <c:pt idx="22">
                  <c:v>130153BX</c:v>
                </c:pt>
                <c:pt idx="23">
                  <c:v>130158BX</c:v>
                </c:pt>
                <c:pt idx="24">
                  <c:v>130159BX</c:v>
                </c:pt>
                <c:pt idx="25">
                  <c:v>130160BX</c:v>
                </c:pt>
                <c:pt idx="26">
                  <c:v>130163BX</c:v>
                </c:pt>
                <c:pt idx="27">
                  <c:v>130165BX</c:v>
                </c:pt>
              </c:strCache>
            </c:strRef>
          </c:cat>
          <c:val>
            <c:numRef>
              <c:f>Sheet1!$F$2:$F$29</c:f>
              <c:numCache>
                <c:formatCode>General</c:formatCode>
                <c:ptCount val="28"/>
                <c:pt idx="0">
                  <c:v>6.72</c:v>
                </c:pt>
                <c:pt idx="1">
                  <c:v>9.4499999999999993</c:v>
                </c:pt>
                <c:pt idx="2">
                  <c:v>7.2</c:v>
                </c:pt>
                <c:pt idx="3">
                  <c:v>6.95</c:v>
                </c:pt>
                <c:pt idx="4">
                  <c:v>5.28</c:v>
                </c:pt>
                <c:pt idx="5">
                  <c:v>6.34</c:v>
                </c:pt>
                <c:pt idx="6">
                  <c:v>4.95</c:v>
                </c:pt>
                <c:pt idx="7">
                  <c:v>7.27</c:v>
                </c:pt>
                <c:pt idx="8">
                  <c:v>4.9800000000000004</c:v>
                </c:pt>
                <c:pt idx="9">
                  <c:v>7.95</c:v>
                </c:pt>
                <c:pt idx="10">
                  <c:v>6.29</c:v>
                </c:pt>
                <c:pt idx="11">
                  <c:v>4.95</c:v>
                </c:pt>
                <c:pt idx="12">
                  <c:v>6.93</c:v>
                </c:pt>
                <c:pt idx="13">
                  <c:v>7.2</c:v>
                </c:pt>
                <c:pt idx="14">
                  <c:v>8.64</c:v>
                </c:pt>
                <c:pt idx="15">
                  <c:v>7.14</c:v>
                </c:pt>
                <c:pt idx="16">
                  <c:v>7.84</c:v>
                </c:pt>
                <c:pt idx="17">
                  <c:v>7.13</c:v>
                </c:pt>
                <c:pt idx="18">
                  <c:v>4.9400000000000004</c:v>
                </c:pt>
                <c:pt idx="19">
                  <c:v>6.54</c:v>
                </c:pt>
                <c:pt idx="20">
                  <c:v>6.53</c:v>
                </c:pt>
                <c:pt idx="21">
                  <c:v>4.3</c:v>
                </c:pt>
                <c:pt idx="22">
                  <c:v>4.4000000000000004</c:v>
                </c:pt>
                <c:pt idx="23">
                  <c:v>6.49</c:v>
                </c:pt>
                <c:pt idx="24">
                  <c:v>6.8</c:v>
                </c:pt>
                <c:pt idx="25">
                  <c:v>7.17</c:v>
                </c:pt>
                <c:pt idx="26">
                  <c:v>6.88</c:v>
                </c:pt>
                <c:pt idx="27">
                  <c:v>6.1</c:v>
                </c:pt>
              </c:numCache>
            </c:numRef>
          </c:val>
          <c:extLst>
            <c:ext xmlns:c16="http://schemas.microsoft.com/office/drawing/2014/chart" uri="{C3380CC4-5D6E-409C-BE32-E72D297353CC}">
              <c16:uniqueId val="{00000000-0DFD-4EBD-B1A6-A5D549D5C437}"/>
            </c:ext>
          </c:extLst>
        </c:ser>
        <c:dLbls>
          <c:showLegendKey val="0"/>
          <c:showVal val="0"/>
          <c:showCatName val="0"/>
          <c:showSerName val="0"/>
          <c:showPercent val="0"/>
          <c:showBubbleSize val="0"/>
        </c:dLbls>
        <c:gapWidth val="219"/>
        <c:overlap val="100"/>
        <c:axId val="151439551"/>
        <c:axId val="155627167"/>
      </c:barChart>
      <c:lineChart>
        <c:grouping val="standard"/>
        <c:varyColors val="0"/>
        <c:ser>
          <c:idx val="0"/>
          <c:order val="0"/>
          <c:tx>
            <c:strRef>
              <c:f>Sheet1!$B$1</c:f>
              <c:strCache>
                <c:ptCount val="1"/>
                <c:pt idx="0">
                  <c:v>AB</c:v>
                </c:pt>
              </c:strCache>
            </c:strRef>
          </c:tx>
          <c:spPr>
            <a:ln w="28575" cap="rnd">
              <a:solidFill>
                <a:schemeClr val="accent1"/>
              </a:solidFill>
              <a:round/>
            </a:ln>
            <a:effectLst/>
          </c:spPr>
          <c:marker>
            <c:symbol val="none"/>
          </c:marker>
          <c:cat>
            <c:strRef>
              <c:f>Sheet1!$A$2:$A$29</c:f>
              <c:strCache>
                <c:ptCount val="28"/>
                <c:pt idx="0">
                  <c:v>124446BX</c:v>
                </c:pt>
                <c:pt idx="1">
                  <c:v>125670BX</c:v>
                </c:pt>
                <c:pt idx="2">
                  <c:v>125671BX</c:v>
                </c:pt>
                <c:pt idx="3">
                  <c:v>125672BX</c:v>
                </c:pt>
                <c:pt idx="4">
                  <c:v>125674BX</c:v>
                </c:pt>
                <c:pt idx="5">
                  <c:v>125675BX</c:v>
                </c:pt>
                <c:pt idx="6">
                  <c:v>126321BX</c:v>
                </c:pt>
                <c:pt idx="7">
                  <c:v>126322BX</c:v>
                </c:pt>
                <c:pt idx="8">
                  <c:v>126323BX</c:v>
                </c:pt>
                <c:pt idx="9">
                  <c:v>127395BX</c:v>
                </c:pt>
                <c:pt idx="10">
                  <c:v>129442BX</c:v>
                </c:pt>
                <c:pt idx="11">
                  <c:v>129444BX</c:v>
                </c:pt>
                <c:pt idx="12">
                  <c:v>129445BX</c:v>
                </c:pt>
                <c:pt idx="13">
                  <c:v>129446BX</c:v>
                </c:pt>
                <c:pt idx="14">
                  <c:v>129447BX</c:v>
                </c:pt>
                <c:pt idx="15">
                  <c:v>129453BX</c:v>
                </c:pt>
                <c:pt idx="16">
                  <c:v>129454BX</c:v>
                </c:pt>
                <c:pt idx="17">
                  <c:v>129455BX</c:v>
                </c:pt>
                <c:pt idx="18">
                  <c:v>129457BX</c:v>
                </c:pt>
                <c:pt idx="19">
                  <c:v>129460BX</c:v>
                </c:pt>
                <c:pt idx="20">
                  <c:v>129465BX</c:v>
                </c:pt>
                <c:pt idx="21">
                  <c:v>130152BX</c:v>
                </c:pt>
                <c:pt idx="22">
                  <c:v>130153BX</c:v>
                </c:pt>
                <c:pt idx="23">
                  <c:v>130158BX</c:v>
                </c:pt>
                <c:pt idx="24">
                  <c:v>130159BX</c:v>
                </c:pt>
                <c:pt idx="25">
                  <c:v>130160BX</c:v>
                </c:pt>
                <c:pt idx="26">
                  <c:v>130163BX</c:v>
                </c:pt>
                <c:pt idx="27">
                  <c:v>130165BX</c:v>
                </c:pt>
              </c:strCache>
            </c:strRef>
          </c:cat>
          <c:val>
            <c:numRef>
              <c:f>Sheet1!$B$2:$B$29</c:f>
              <c:numCache>
                <c:formatCode>General</c:formatCode>
                <c:ptCount val="28"/>
                <c:pt idx="0">
                  <c:v>641320</c:v>
                </c:pt>
                <c:pt idx="1">
                  <c:v>792257</c:v>
                </c:pt>
                <c:pt idx="2">
                  <c:v>657909</c:v>
                </c:pt>
                <c:pt idx="3">
                  <c:v>611578</c:v>
                </c:pt>
                <c:pt idx="4">
                  <c:v>472796</c:v>
                </c:pt>
                <c:pt idx="5">
                  <c:v>545142</c:v>
                </c:pt>
                <c:pt idx="6">
                  <c:v>489653</c:v>
                </c:pt>
                <c:pt idx="7">
                  <c:v>634950</c:v>
                </c:pt>
                <c:pt idx="8">
                  <c:v>496771</c:v>
                </c:pt>
                <c:pt idx="9">
                  <c:v>706413</c:v>
                </c:pt>
                <c:pt idx="10">
                  <c:v>581303</c:v>
                </c:pt>
                <c:pt idx="11">
                  <c:v>480369</c:v>
                </c:pt>
                <c:pt idx="12">
                  <c:v>646039</c:v>
                </c:pt>
                <c:pt idx="13">
                  <c:v>670110</c:v>
                </c:pt>
                <c:pt idx="14">
                  <c:v>752801</c:v>
                </c:pt>
                <c:pt idx="15">
                  <c:v>673379</c:v>
                </c:pt>
                <c:pt idx="16">
                  <c:v>706637</c:v>
                </c:pt>
                <c:pt idx="17">
                  <c:v>646929</c:v>
                </c:pt>
                <c:pt idx="18">
                  <c:v>478664</c:v>
                </c:pt>
                <c:pt idx="19">
                  <c:v>604872</c:v>
                </c:pt>
                <c:pt idx="20">
                  <c:v>643033</c:v>
                </c:pt>
                <c:pt idx="21">
                  <c:v>434672</c:v>
                </c:pt>
                <c:pt idx="22">
                  <c:v>424871</c:v>
                </c:pt>
                <c:pt idx="23">
                  <c:v>620199</c:v>
                </c:pt>
                <c:pt idx="24">
                  <c:v>636736</c:v>
                </c:pt>
                <c:pt idx="25">
                  <c:v>647029</c:v>
                </c:pt>
                <c:pt idx="26">
                  <c:v>643490</c:v>
                </c:pt>
                <c:pt idx="27">
                  <c:v>589932</c:v>
                </c:pt>
              </c:numCache>
            </c:numRef>
          </c:val>
          <c:smooth val="0"/>
          <c:extLst>
            <c:ext xmlns:c16="http://schemas.microsoft.com/office/drawing/2014/chart" uri="{C3380CC4-5D6E-409C-BE32-E72D297353CC}">
              <c16:uniqueId val="{00000001-0DFD-4EBD-B1A6-A5D549D5C437}"/>
            </c:ext>
          </c:extLst>
        </c:ser>
        <c:ser>
          <c:idx val="1"/>
          <c:order val="1"/>
          <c:tx>
            <c:strRef>
              <c:f>Sheet1!$C$1</c:f>
              <c:strCache>
                <c:ptCount val="1"/>
                <c:pt idx="0">
                  <c:v>B</c:v>
                </c:pt>
              </c:strCache>
            </c:strRef>
          </c:tx>
          <c:spPr>
            <a:ln w="28575" cap="rnd">
              <a:solidFill>
                <a:schemeClr val="accent2"/>
              </a:solidFill>
              <a:round/>
            </a:ln>
            <a:effectLst/>
          </c:spPr>
          <c:marker>
            <c:symbol val="none"/>
          </c:marker>
          <c:cat>
            <c:strRef>
              <c:f>Sheet1!$A$2:$A$29</c:f>
              <c:strCache>
                <c:ptCount val="28"/>
                <c:pt idx="0">
                  <c:v>124446BX</c:v>
                </c:pt>
                <c:pt idx="1">
                  <c:v>125670BX</c:v>
                </c:pt>
                <c:pt idx="2">
                  <c:v>125671BX</c:v>
                </c:pt>
                <c:pt idx="3">
                  <c:v>125672BX</c:v>
                </c:pt>
                <c:pt idx="4">
                  <c:v>125674BX</c:v>
                </c:pt>
                <c:pt idx="5">
                  <c:v>125675BX</c:v>
                </c:pt>
                <c:pt idx="6">
                  <c:v>126321BX</c:v>
                </c:pt>
                <c:pt idx="7">
                  <c:v>126322BX</c:v>
                </c:pt>
                <c:pt idx="8">
                  <c:v>126323BX</c:v>
                </c:pt>
                <c:pt idx="9">
                  <c:v>127395BX</c:v>
                </c:pt>
                <c:pt idx="10">
                  <c:v>129442BX</c:v>
                </c:pt>
                <c:pt idx="11">
                  <c:v>129444BX</c:v>
                </c:pt>
                <c:pt idx="12">
                  <c:v>129445BX</c:v>
                </c:pt>
                <c:pt idx="13">
                  <c:v>129446BX</c:v>
                </c:pt>
                <c:pt idx="14">
                  <c:v>129447BX</c:v>
                </c:pt>
                <c:pt idx="15">
                  <c:v>129453BX</c:v>
                </c:pt>
                <c:pt idx="16">
                  <c:v>129454BX</c:v>
                </c:pt>
                <c:pt idx="17">
                  <c:v>129455BX</c:v>
                </c:pt>
                <c:pt idx="18">
                  <c:v>129457BX</c:v>
                </c:pt>
                <c:pt idx="19">
                  <c:v>129460BX</c:v>
                </c:pt>
                <c:pt idx="20">
                  <c:v>129465BX</c:v>
                </c:pt>
                <c:pt idx="21">
                  <c:v>130152BX</c:v>
                </c:pt>
                <c:pt idx="22">
                  <c:v>130153BX</c:v>
                </c:pt>
                <c:pt idx="23">
                  <c:v>130158BX</c:v>
                </c:pt>
                <c:pt idx="24">
                  <c:v>130159BX</c:v>
                </c:pt>
                <c:pt idx="25">
                  <c:v>130160BX</c:v>
                </c:pt>
                <c:pt idx="26">
                  <c:v>130163BX</c:v>
                </c:pt>
                <c:pt idx="27">
                  <c:v>130165BX</c:v>
                </c:pt>
              </c:strCache>
            </c:strRef>
          </c:cat>
          <c:val>
            <c:numRef>
              <c:f>Sheet1!$C$2:$C$29</c:f>
              <c:numCache>
                <c:formatCode>General</c:formatCode>
                <c:ptCount val="28"/>
                <c:pt idx="0">
                  <c:v>631529</c:v>
                </c:pt>
                <c:pt idx="1">
                  <c:v>764970</c:v>
                </c:pt>
                <c:pt idx="2">
                  <c:v>642079</c:v>
                </c:pt>
                <c:pt idx="3">
                  <c:v>622636</c:v>
                </c:pt>
                <c:pt idx="4">
                  <c:v>472723</c:v>
                </c:pt>
                <c:pt idx="5">
                  <c:v>566366</c:v>
                </c:pt>
                <c:pt idx="6">
                  <c:v>447233</c:v>
                </c:pt>
                <c:pt idx="7">
                  <c:v>545949</c:v>
                </c:pt>
                <c:pt idx="8">
                  <c:v>442070</c:v>
                </c:pt>
                <c:pt idx="9">
                  <c:v>718741</c:v>
                </c:pt>
                <c:pt idx="10">
                  <c:v>583184</c:v>
                </c:pt>
                <c:pt idx="11">
                  <c:v>415106</c:v>
                </c:pt>
                <c:pt idx="12">
                  <c:v>622834</c:v>
                </c:pt>
                <c:pt idx="13">
                  <c:v>623773</c:v>
                </c:pt>
                <c:pt idx="14">
                  <c:v>760949</c:v>
                </c:pt>
                <c:pt idx="15">
                  <c:v>648509</c:v>
                </c:pt>
                <c:pt idx="16">
                  <c:v>677309</c:v>
                </c:pt>
                <c:pt idx="17">
                  <c:v>669423</c:v>
                </c:pt>
                <c:pt idx="18">
                  <c:v>421101</c:v>
                </c:pt>
                <c:pt idx="19">
                  <c:v>621041</c:v>
                </c:pt>
                <c:pt idx="20">
                  <c:v>578908</c:v>
                </c:pt>
                <c:pt idx="21">
                  <c:v>379330</c:v>
                </c:pt>
                <c:pt idx="22">
                  <c:v>383884</c:v>
                </c:pt>
                <c:pt idx="23">
                  <c:v>628326</c:v>
                </c:pt>
                <c:pt idx="24">
                  <c:v>639588</c:v>
                </c:pt>
                <c:pt idx="25">
                  <c:v>679075</c:v>
                </c:pt>
                <c:pt idx="26">
                  <c:v>634246</c:v>
                </c:pt>
                <c:pt idx="27">
                  <c:v>574960</c:v>
                </c:pt>
              </c:numCache>
            </c:numRef>
          </c:val>
          <c:smooth val="0"/>
          <c:extLst>
            <c:ext xmlns:c16="http://schemas.microsoft.com/office/drawing/2014/chart" uri="{C3380CC4-5D6E-409C-BE32-E72D297353CC}">
              <c16:uniqueId val="{00000002-0DFD-4EBD-B1A6-A5D549D5C437}"/>
            </c:ext>
          </c:extLst>
        </c:ser>
        <c:ser>
          <c:idx val="2"/>
          <c:order val="2"/>
          <c:tx>
            <c:strRef>
              <c:f>Sheet1!$D$1</c:f>
              <c:strCache>
                <c:ptCount val="1"/>
                <c:pt idx="0">
                  <c:v>AAB</c:v>
                </c:pt>
              </c:strCache>
            </c:strRef>
          </c:tx>
          <c:spPr>
            <a:ln w="28575" cap="rnd">
              <a:solidFill>
                <a:schemeClr val="accent3"/>
              </a:solidFill>
              <a:round/>
            </a:ln>
            <a:effectLst/>
          </c:spPr>
          <c:marker>
            <c:symbol val="none"/>
          </c:marker>
          <c:cat>
            <c:strRef>
              <c:f>Sheet1!$A$2:$A$29</c:f>
              <c:strCache>
                <c:ptCount val="28"/>
                <c:pt idx="0">
                  <c:v>124446BX</c:v>
                </c:pt>
                <c:pt idx="1">
                  <c:v>125670BX</c:v>
                </c:pt>
                <c:pt idx="2">
                  <c:v>125671BX</c:v>
                </c:pt>
                <c:pt idx="3">
                  <c:v>125672BX</c:v>
                </c:pt>
                <c:pt idx="4">
                  <c:v>125674BX</c:v>
                </c:pt>
                <c:pt idx="5">
                  <c:v>125675BX</c:v>
                </c:pt>
                <c:pt idx="6">
                  <c:v>126321BX</c:v>
                </c:pt>
                <c:pt idx="7">
                  <c:v>126322BX</c:v>
                </c:pt>
                <c:pt idx="8">
                  <c:v>126323BX</c:v>
                </c:pt>
                <c:pt idx="9">
                  <c:v>127395BX</c:v>
                </c:pt>
                <c:pt idx="10">
                  <c:v>129442BX</c:v>
                </c:pt>
                <c:pt idx="11">
                  <c:v>129444BX</c:v>
                </c:pt>
                <c:pt idx="12">
                  <c:v>129445BX</c:v>
                </c:pt>
                <c:pt idx="13">
                  <c:v>129446BX</c:v>
                </c:pt>
                <c:pt idx="14">
                  <c:v>129447BX</c:v>
                </c:pt>
                <c:pt idx="15">
                  <c:v>129453BX</c:v>
                </c:pt>
                <c:pt idx="16">
                  <c:v>129454BX</c:v>
                </c:pt>
                <c:pt idx="17">
                  <c:v>129455BX</c:v>
                </c:pt>
                <c:pt idx="18">
                  <c:v>129457BX</c:v>
                </c:pt>
                <c:pt idx="19">
                  <c:v>129460BX</c:v>
                </c:pt>
                <c:pt idx="20">
                  <c:v>129465BX</c:v>
                </c:pt>
                <c:pt idx="21">
                  <c:v>130152BX</c:v>
                </c:pt>
                <c:pt idx="22">
                  <c:v>130153BX</c:v>
                </c:pt>
                <c:pt idx="23">
                  <c:v>130158BX</c:v>
                </c:pt>
                <c:pt idx="24">
                  <c:v>130159BX</c:v>
                </c:pt>
                <c:pt idx="25">
                  <c:v>130160BX</c:v>
                </c:pt>
                <c:pt idx="26">
                  <c:v>130163BX</c:v>
                </c:pt>
                <c:pt idx="27">
                  <c:v>130165BX</c:v>
                </c:pt>
              </c:strCache>
            </c:strRef>
          </c:cat>
          <c:val>
            <c:numRef>
              <c:f>Sheet1!$D$2:$D$29</c:f>
              <c:numCache>
                <c:formatCode>General</c:formatCode>
                <c:ptCount val="28"/>
                <c:pt idx="0">
                  <c:v>1422672</c:v>
                </c:pt>
                <c:pt idx="1">
                  <c:v>1856007</c:v>
                </c:pt>
                <c:pt idx="2">
                  <c:v>1288628</c:v>
                </c:pt>
                <c:pt idx="3">
                  <c:v>1202928</c:v>
                </c:pt>
                <c:pt idx="4">
                  <c:v>809155</c:v>
                </c:pt>
                <c:pt idx="5">
                  <c:v>907691</c:v>
                </c:pt>
                <c:pt idx="6">
                  <c:v>984260</c:v>
                </c:pt>
                <c:pt idx="7">
                  <c:v>1800588</c:v>
                </c:pt>
                <c:pt idx="8">
                  <c:v>1094807</c:v>
                </c:pt>
                <c:pt idx="9">
                  <c:v>1608007</c:v>
                </c:pt>
                <c:pt idx="10">
                  <c:v>1329432</c:v>
                </c:pt>
                <c:pt idx="11">
                  <c:v>1144728</c:v>
                </c:pt>
                <c:pt idx="12">
                  <c:v>1425357</c:v>
                </c:pt>
                <c:pt idx="13">
                  <c:v>1727369</c:v>
                </c:pt>
                <c:pt idx="14">
                  <c:v>1879986</c:v>
                </c:pt>
                <c:pt idx="15">
                  <c:v>1408174</c:v>
                </c:pt>
                <c:pt idx="16">
                  <c:v>1653165</c:v>
                </c:pt>
                <c:pt idx="17">
                  <c:v>1311285</c:v>
                </c:pt>
                <c:pt idx="18">
                  <c:v>1122964</c:v>
                </c:pt>
                <c:pt idx="19">
                  <c:v>1122634</c:v>
                </c:pt>
                <c:pt idx="20">
                  <c:v>1632045</c:v>
                </c:pt>
                <c:pt idx="21">
                  <c:v>947611</c:v>
                </c:pt>
                <c:pt idx="22">
                  <c:v>855710</c:v>
                </c:pt>
                <c:pt idx="23">
                  <c:v>1499910</c:v>
                </c:pt>
                <c:pt idx="24">
                  <c:v>1372930</c:v>
                </c:pt>
                <c:pt idx="25">
                  <c:v>1179099</c:v>
                </c:pt>
                <c:pt idx="26">
                  <c:v>1175002</c:v>
                </c:pt>
                <c:pt idx="27">
                  <c:v>1084186</c:v>
                </c:pt>
              </c:numCache>
            </c:numRef>
          </c:val>
          <c:smooth val="0"/>
          <c:extLst>
            <c:ext xmlns:c16="http://schemas.microsoft.com/office/drawing/2014/chart" uri="{C3380CC4-5D6E-409C-BE32-E72D297353CC}">
              <c16:uniqueId val="{00000003-0DFD-4EBD-B1A6-A5D549D5C437}"/>
            </c:ext>
          </c:extLst>
        </c:ser>
        <c:ser>
          <c:idx val="3"/>
          <c:order val="3"/>
          <c:tx>
            <c:strRef>
              <c:f>Sheet1!$E$1</c:f>
              <c:strCache>
                <c:ptCount val="1"/>
                <c:pt idx="0">
                  <c:v>ABB</c:v>
                </c:pt>
              </c:strCache>
            </c:strRef>
          </c:tx>
          <c:spPr>
            <a:ln w="28575" cap="rnd">
              <a:solidFill>
                <a:schemeClr val="accent4"/>
              </a:solidFill>
              <a:round/>
            </a:ln>
            <a:effectLst/>
          </c:spPr>
          <c:marker>
            <c:symbol val="none"/>
          </c:marker>
          <c:cat>
            <c:strRef>
              <c:f>Sheet1!$A$2:$A$29</c:f>
              <c:strCache>
                <c:ptCount val="28"/>
                <c:pt idx="0">
                  <c:v>124446BX</c:v>
                </c:pt>
                <c:pt idx="1">
                  <c:v>125670BX</c:v>
                </c:pt>
                <c:pt idx="2">
                  <c:v>125671BX</c:v>
                </c:pt>
                <c:pt idx="3">
                  <c:v>125672BX</c:v>
                </c:pt>
                <c:pt idx="4">
                  <c:v>125674BX</c:v>
                </c:pt>
                <c:pt idx="5">
                  <c:v>125675BX</c:v>
                </c:pt>
                <c:pt idx="6">
                  <c:v>126321BX</c:v>
                </c:pt>
                <c:pt idx="7">
                  <c:v>126322BX</c:v>
                </c:pt>
                <c:pt idx="8">
                  <c:v>126323BX</c:v>
                </c:pt>
                <c:pt idx="9">
                  <c:v>127395BX</c:v>
                </c:pt>
                <c:pt idx="10">
                  <c:v>129442BX</c:v>
                </c:pt>
                <c:pt idx="11">
                  <c:v>129444BX</c:v>
                </c:pt>
                <c:pt idx="12">
                  <c:v>129445BX</c:v>
                </c:pt>
                <c:pt idx="13">
                  <c:v>129446BX</c:v>
                </c:pt>
                <c:pt idx="14">
                  <c:v>129447BX</c:v>
                </c:pt>
                <c:pt idx="15">
                  <c:v>129453BX</c:v>
                </c:pt>
                <c:pt idx="16">
                  <c:v>129454BX</c:v>
                </c:pt>
                <c:pt idx="17">
                  <c:v>129455BX</c:v>
                </c:pt>
                <c:pt idx="18">
                  <c:v>129457BX</c:v>
                </c:pt>
                <c:pt idx="19">
                  <c:v>129460BX</c:v>
                </c:pt>
                <c:pt idx="20">
                  <c:v>129465BX</c:v>
                </c:pt>
                <c:pt idx="21">
                  <c:v>130152BX</c:v>
                </c:pt>
                <c:pt idx="22">
                  <c:v>130153BX</c:v>
                </c:pt>
                <c:pt idx="23">
                  <c:v>130158BX</c:v>
                </c:pt>
                <c:pt idx="24">
                  <c:v>130159BX</c:v>
                </c:pt>
                <c:pt idx="25">
                  <c:v>130160BX</c:v>
                </c:pt>
                <c:pt idx="26">
                  <c:v>130163BX</c:v>
                </c:pt>
                <c:pt idx="27">
                  <c:v>130165BX</c:v>
                </c:pt>
              </c:strCache>
            </c:strRef>
          </c:cat>
          <c:val>
            <c:numRef>
              <c:f>Sheet1!$E$2:$E$29</c:f>
              <c:numCache>
                <c:formatCode>General</c:formatCode>
                <c:ptCount val="28"/>
                <c:pt idx="0">
                  <c:v>236073</c:v>
                </c:pt>
                <c:pt idx="1">
                  <c:v>289263</c:v>
                </c:pt>
                <c:pt idx="2">
                  <c:v>252400</c:v>
                </c:pt>
                <c:pt idx="3">
                  <c:v>235881</c:v>
                </c:pt>
                <c:pt idx="4">
                  <c:v>189035</c:v>
                </c:pt>
                <c:pt idx="5">
                  <c:v>218219</c:v>
                </c:pt>
                <c:pt idx="6">
                  <c:v>186191</c:v>
                </c:pt>
                <c:pt idx="7">
                  <c:v>222303</c:v>
                </c:pt>
                <c:pt idx="8">
                  <c:v>181942</c:v>
                </c:pt>
                <c:pt idx="9">
                  <c:v>263235</c:v>
                </c:pt>
                <c:pt idx="10">
                  <c:v>218050</c:v>
                </c:pt>
                <c:pt idx="11">
                  <c:v>170393</c:v>
                </c:pt>
                <c:pt idx="12">
                  <c:v>244955</c:v>
                </c:pt>
                <c:pt idx="13">
                  <c:v>245709</c:v>
                </c:pt>
                <c:pt idx="14">
                  <c:v>277032</c:v>
                </c:pt>
                <c:pt idx="15">
                  <c:v>256564</c:v>
                </c:pt>
                <c:pt idx="16">
                  <c:v>267322</c:v>
                </c:pt>
                <c:pt idx="17">
                  <c:v>249388</c:v>
                </c:pt>
                <c:pt idx="18">
                  <c:v>171736</c:v>
                </c:pt>
                <c:pt idx="19">
                  <c:v>228129</c:v>
                </c:pt>
                <c:pt idx="20">
                  <c:v>235727</c:v>
                </c:pt>
                <c:pt idx="21">
                  <c:v>156030</c:v>
                </c:pt>
                <c:pt idx="22">
                  <c:v>152205</c:v>
                </c:pt>
                <c:pt idx="23">
                  <c:v>230505</c:v>
                </c:pt>
                <c:pt idx="24">
                  <c:v>240486</c:v>
                </c:pt>
                <c:pt idx="25">
                  <c:v>243829</c:v>
                </c:pt>
                <c:pt idx="26">
                  <c:v>246720</c:v>
                </c:pt>
                <c:pt idx="27">
                  <c:v>228916</c:v>
                </c:pt>
              </c:numCache>
            </c:numRef>
          </c:val>
          <c:smooth val="0"/>
          <c:extLst>
            <c:ext xmlns:c16="http://schemas.microsoft.com/office/drawing/2014/chart" uri="{C3380CC4-5D6E-409C-BE32-E72D297353CC}">
              <c16:uniqueId val="{00000004-0DFD-4EBD-B1A6-A5D549D5C437}"/>
            </c:ext>
          </c:extLst>
        </c:ser>
        <c:dLbls>
          <c:showLegendKey val="0"/>
          <c:showVal val="0"/>
          <c:showCatName val="0"/>
          <c:showSerName val="0"/>
          <c:showPercent val="0"/>
          <c:showBubbleSize val="0"/>
        </c:dLbls>
        <c:marker val="1"/>
        <c:smooth val="0"/>
        <c:axId val="151472495"/>
        <c:axId val="2119275407"/>
      </c:lineChart>
      <c:catAx>
        <c:axId val="151472495"/>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crossAx val="2119275407"/>
        <c:crosses val="autoZero"/>
        <c:auto val="1"/>
        <c:lblAlgn val="ctr"/>
        <c:lblOffset val="100"/>
        <c:noMultiLvlLbl val="0"/>
      </c:catAx>
      <c:valAx>
        <c:axId val="2119275407"/>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crossAx val="151472495"/>
        <c:crosses val="autoZero"/>
        <c:crossBetween val="between"/>
      </c:valAx>
      <c:valAx>
        <c:axId val="155627167"/>
        <c:scaling>
          <c:orientation val="minMax"/>
        </c:scaling>
        <c:delete val="0"/>
        <c:axPos val="r"/>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crossAx val="151439551"/>
        <c:crosses val="max"/>
        <c:crossBetween val="between"/>
      </c:valAx>
      <c:catAx>
        <c:axId val="151439551"/>
        <c:scaling>
          <c:orientation val="minMax"/>
        </c:scaling>
        <c:delete val="1"/>
        <c:axPos val="b"/>
        <c:numFmt formatCode="General" sourceLinked="1"/>
        <c:majorTickMark val="out"/>
        <c:minorTickMark val="none"/>
        <c:tickLblPos val="nextTo"/>
        <c:crossAx val="155627167"/>
        <c:crosses val="autoZero"/>
        <c:auto val="1"/>
        <c:lblAlgn val="ctr"/>
        <c:lblOffset val="100"/>
        <c:noMultiLvlLbl val="0"/>
      </c:cat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zh-CN"/>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2670414-DC4B-45C4-9AFF-67B4512E680F}" type="datetimeFigureOut">
              <a:rPr lang="zh-CN" altLang="en-US" smtClean="0"/>
              <a:t>2023/9/8</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17ECB27-7228-477D-8C1F-79C66535C0E9}" type="slidenum">
              <a:rPr lang="zh-CN" altLang="en-US" smtClean="0"/>
              <a:t>‹#›</a:t>
            </a:fld>
            <a:endParaRPr lang="zh-CN" altLang="en-US"/>
          </a:p>
        </p:txBody>
      </p:sp>
    </p:spTree>
    <p:extLst>
      <p:ext uri="{BB962C8B-B14F-4D97-AF65-F5344CB8AC3E}">
        <p14:creationId xmlns:p14="http://schemas.microsoft.com/office/powerpoint/2010/main" val="24910355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A17ECB27-7228-477D-8C1F-79C66535C0E9}" type="slidenum">
              <a:rPr lang="zh-CN" altLang="en-US" smtClean="0"/>
              <a:t>1</a:t>
            </a:fld>
            <a:endParaRPr lang="zh-CN" altLang="en-US"/>
          </a:p>
        </p:txBody>
      </p:sp>
    </p:spTree>
    <p:extLst>
      <p:ext uri="{BB962C8B-B14F-4D97-AF65-F5344CB8AC3E}">
        <p14:creationId xmlns:p14="http://schemas.microsoft.com/office/powerpoint/2010/main" val="385899898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2AA7E12-E9A3-08D5-AE79-B64C70C5B78A}"/>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B5FFB0F7-705B-00EA-4A30-DEAB7709052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FB66DB62-A246-5463-79EB-9FAB4625F337}"/>
              </a:ext>
            </a:extLst>
          </p:cNvPr>
          <p:cNvSpPr>
            <a:spLocks noGrp="1"/>
          </p:cNvSpPr>
          <p:nvPr>
            <p:ph type="dt" sz="half" idx="10"/>
          </p:nvPr>
        </p:nvSpPr>
        <p:spPr/>
        <p:txBody>
          <a:bodyPr/>
          <a:lstStyle/>
          <a:p>
            <a:fld id="{AC930200-4F53-4E12-BAB6-62956348303A}" type="datetimeFigureOut">
              <a:rPr lang="zh-CN" altLang="en-US" smtClean="0"/>
              <a:t>2023/9/8</a:t>
            </a:fld>
            <a:endParaRPr lang="zh-CN" altLang="en-US"/>
          </a:p>
        </p:txBody>
      </p:sp>
      <p:sp>
        <p:nvSpPr>
          <p:cNvPr id="5" name="页脚占位符 4">
            <a:extLst>
              <a:ext uri="{FF2B5EF4-FFF2-40B4-BE49-F238E27FC236}">
                <a16:creationId xmlns:a16="http://schemas.microsoft.com/office/drawing/2014/main" id="{4A31B83F-6D27-4400-7D0F-07C75EF202AA}"/>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A2C23C46-AB42-5AA7-2AC1-DBA8FAABD72A}"/>
              </a:ext>
            </a:extLst>
          </p:cNvPr>
          <p:cNvSpPr>
            <a:spLocks noGrp="1"/>
          </p:cNvSpPr>
          <p:nvPr>
            <p:ph type="sldNum" sz="quarter" idx="12"/>
          </p:nvPr>
        </p:nvSpPr>
        <p:spPr/>
        <p:txBody>
          <a:body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28419138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5382829-FC1D-B72A-E08C-E138A0C51E6B}"/>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EBBD62E3-4FEE-FD9F-7D87-03BBA9AEE055}"/>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9AC8BBA-A79B-8B31-AF03-C7DC845489F1}"/>
              </a:ext>
            </a:extLst>
          </p:cNvPr>
          <p:cNvSpPr>
            <a:spLocks noGrp="1"/>
          </p:cNvSpPr>
          <p:nvPr>
            <p:ph type="dt" sz="half" idx="10"/>
          </p:nvPr>
        </p:nvSpPr>
        <p:spPr/>
        <p:txBody>
          <a:bodyPr/>
          <a:lstStyle/>
          <a:p>
            <a:fld id="{AC930200-4F53-4E12-BAB6-62956348303A}" type="datetimeFigureOut">
              <a:rPr lang="zh-CN" altLang="en-US" smtClean="0"/>
              <a:t>2023/9/8</a:t>
            </a:fld>
            <a:endParaRPr lang="zh-CN" altLang="en-US"/>
          </a:p>
        </p:txBody>
      </p:sp>
      <p:sp>
        <p:nvSpPr>
          <p:cNvPr id="5" name="页脚占位符 4">
            <a:extLst>
              <a:ext uri="{FF2B5EF4-FFF2-40B4-BE49-F238E27FC236}">
                <a16:creationId xmlns:a16="http://schemas.microsoft.com/office/drawing/2014/main" id="{0FF51F13-5BD0-C199-8696-7B1C6B3CD72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57E939D7-4C76-B4B8-9283-1FEF8153E28F}"/>
              </a:ext>
            </a:extLst>
          </p:cNvPr>
          <p:cNvSpPr>
            <a:spLocks noGrp="1"/>
          </p:cNvSpPr>
          <p:nvPr>
            <p:ph type="sldNum" sz="quarter" idx="12"/>
          </p:nvPr>
        </p:nvSpPr>
        <p:spPr/>
        <p:txBody>
          <a:body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39404236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86716F88-927E-498A-45DC-87CB653A4599}"/>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B17D7019-505E-4810-E8B0-2638FA5ECC7E}"/>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E641A37E-ED2E-6CF7-AA6A-FA2FEDBA3616}"/>
              </a:ext>
            </a:extLst>
          </p:cNvPr>
          <p:cNvSpPr>
            <a:spLocks noGrp="1"/>
          </p:cNvSpPr>
          <p:nvPr>
            <p:ph type="dt" sz="half" idx="10"/>
          </p:nvPr>
        </p:nvSpPr>
        <p:spPr/>
        <p:txBody>
          <a:bodyPr/>
          <a:lstStyle/>
          <a:p>
            <a:fld id="{AC930200-4F53-4E12-BAB6-62956348303A}" type="datetimeFigureOut">
              <a:rPr lang="zh-CN" altLang="en-US" smtClean="0"/>
              <a:t>2023/9/8</a:t>
            </a:fld>
            <a:endParaRPr lang="zh-CN" altLang="en-US"/>
          </a:p>
        </p:txBody>
      </p:sp>
      <p:sp>
        <p:nvSpPr>
          <p:cNvPr id="5" name="页脚占位符 4">
            <a:extLst>
              <a:ext uri="{FF2B5EF4-FFF2-40B4-BE49-F238E27FC236}">
                <a16:creationId xmlns:a16="http://schemas.microsoft.com/office/drawing/2014/main" id="{44D12EC4-1906-DFDE-258F-7FCA5DE9509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FD916C42-5375-8D2B-92E1-3248AE929FDC}"/>
              </a:ext>
            </a:extLst>
          </p:cNvPr>
          <p:cNvSpPr>
            <a:spLocks noGrp="1"/>
          </p:cNvSpPr>
          <p:nvPr>
            <p:ph type="sldNum" sz="quarter" idx="12"/>
          </p:nvPr>
        </p:nvSpPr>
        <p:spPr/>
        <p:txBody>
          <a:body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291923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4E6CA89-4860-2E44-BE59-74026E3CD206}"/>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8E10CBC9-91C4-73C9-1A61-7B05B7F8B931}"/>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BD713E99-0BEE-4AA4-BFD1-402BAEA6B09B}"/>
              </a:ext>
            </a:extLst>
          </p:cNvPr>
          <p:cNvSpPr>
            <a:spLocks noGrp="1"/>
          </p:cNvSpPr>
          <p:nvPr>
            <p:ph type="dt" sz="half" idx="10"/>
          </p:nvPr>
        </p:nvSpPr>
        <p:spPr/>
        <p:txBody>
          <a:bodyPr/>
          <a:lstStyle/>
          <a:p>
            <a:fld id="{AC930200-4F53-4E12-BAB6-62956348303A}" type="datetimeFigureOut">
              <a:rPr lang="zh-CN" altLang="en-US" smtClean="0"/>
              <a:t>2023/9/8</a:t>
            </a:fld>
            <a:endParaRPr lang="zh-CN" altLang="en-US"/>
          </a:p>
        </p:txBody>
      </p:sp>
      <p:sp>
        <p:nvSpPr>
          <p:cNvPr id="5" name="页脚占位符 4">
            <a:extLst>
              <a:ext uri="{FF2B5EF4-FFF2-40B4-BE49-F238E27FC236}">
                <a16:creationId xmlns:a16="http://schemas.microsoft.com/office/drawing/2014/main" id="{FB24AF87-5A4F-1462-7012-DF9B831869B7}"/>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C92AE49-AEED-17CD-80F8-F8A9C35DC129}"/>
              </a:ext>
            </a:extLst>
          </p:cNvPr>
          <p:cNvSpPr>
            <a:spLocks noGrp="1"/>
          </p:cNvSpPr>
          <p:nvPr>
            <p:ph type="sldNum" sz="quarter" idx="12"/>
          </p:nvPr>
        </p:nvSpPr>
        <p:spPr/>
        <p:txBody>
          <a:body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22447798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ED5D957-1080-245E-03EC-4A32C16AB457}"/>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D697BC3E-7ECA-8BF9-9B5B-CD20EA08B07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A6C4676C-ADE9-9250-B840-B6D613FB442A}"/>
              </a:ext>
            </a:extLst>
          </p:cNvPr>
          <p:cNvSpPr>
            <a:spLocks noGrp="1"/>
          </p:cNvSpPr>
          <p:nvPr>
            <p:ph type="dt" sz="half" idx="10"/>
          </p:nvPr>
        </p:nvSpPr>
        <p:spPr/>
        <p:txBody>
          <a:bodyPr/>
          <a:lstStyle/>
          <a:p>
            <a:fld id="{AC930200-4F53-4E12-BAB6-62956348303A}" type="datetimeFigureOut">
              <a:rPr lang="zh-CN" altLang="en-US" smtClean="0"/>
              <a:t>2023/9/8</a:t>
            </a:fld>
            <a:endParaRPr lang="zh-CN" altLang="en-US"/>
          </a:p>
        </p:txBody>
      </p:sp>
      <p:sp>
        <p:nvSpPr>
          <p:cNvPr id="5" name="页脚占位符 4">
            <a:extLst>
              <a:ext uri="{FF2B5EF4-FFF2-40B4-BE49-F238E27FC236}">
                <a16:creationId xmlns:a16="http://schemas.microsoft.com/office/drawing/2014/main" id="{C9721D80-E04A-74D6-AFA6-8AF255E4FD35}"/>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E7BB0241-8852-2A75-4BDC-376424271837}"/>
              </a:ext>
            </a:extLst>
          </p:cNvPr>
          <p:cNvSpPr>
            <a:spLocks noGrp="1"/>
          </p:cNvSpPr>
          <p:nvPr>
            <p:ph type="sldNum" sz="quarter" idx="12"/>
          </p:nvPr>
        </p:nvSpPr>
        <p:spPr/>
        <p:txBody>
          <a:body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6373765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D3D28AF-A234-4C9A-6A78-72A6BDECEA0F}"/>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C6A20BB5-A301-2E80-CBD5-37AD0276324E}"/>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3B9F2367-D6DC-E497-D8D8-A2446AE0EF13}"/>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C37E2A06-4862-80B7-8E62-C4FC9385A39F}"/>
              </a:ext>
            </a:extLst>
          </p:cNvPr>
          <p:cNvSpPr>
            <a:spLocks noGrp="1"/>
          </p:cNvSpPr>
          <p:nvPr>
            <p:ph type="dt" sz="half" idx="10"/>
          </p:nvPr>
        </p:nvSpPr>
        <p:spPr/>
        <p:txBody>
          <a:bodyPr/>
          <a:lstStyle/>
          <a:p>
            <a:fld id="{AC930200-4F53-4E12-BAB6-62956348303A}" type="datetimeFigureOut">
              <a:rPr lang="zh-CN" altLang="en-US" smtClean="0"/>
              <a:t>2023/9/8</a:t>
            </a:fld>
            <a:endParaRPr lang="zh-CN" altLang="en-US"/>
          </a:p>
        </p:txBody>
      </p:sp>
      <p:sp>
        <p:nvSpPr>
          <p:cNvPr id="6" name="页脚占位符 5">
            <a:extLst>
              <a:ext uri="{FF2B5EF4-FFF2-40B4-BE49-F238E27FC236}">
                <a16:creationId xmlns:a16="http://schemas.microsoft.com/office/drawing/2014/main" id="{2DE04901-C391-6509-AE7C-611E0FD8267B}"/>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E8D01AEA-98BE-440C-B4AC-699464B7805B}"/>
              </a:ext>
            </a:extLst>
          </p:cNvPr>
          <p:cNvSpPr>
            <a:spLocks noGrp="1"/>
          </p:cNvSpPr>
          <p:nvPr>
            <p:ph type="sldNum" sz="quarter" idx="12"/>
          </p:nvPr>
        </p:nvSpPr>
        <p:spPr/>
        <p:txBody>
          <a:body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39247406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391BDD7-2766-08B8-0F5A-20784576E93B}"/>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7BC579CA-7B9F-F89F-2244-A61C5150EC6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3CC520AC-9DD5-B405-6620-6864667F196F}"/>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38B34CFD-14B7-F189-4B80-5E0057C040D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1396EB04-E445-A279-E549-3943E2EFF2A6}"/>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F0C70C73-CB36-011E-5E9B-4157B1F8211A}"/>
              </a:ext>
            </a:extLst>
          </p:cNvPr>
          <p:cNvSpPr>
            <a:spLocks noGrp="1"/>
          </p:cNvSpPr>
          <p:nvPr>
            <p:ph type="dt" sz="half" idx="10"/>
          </p:nvPr>
        </p:nvSpPr>
        <p:spPr/>
        <p:txBody>
          <a:bodyPr/>
          <a:lstStyle/>
          <a:p>
            <a:fld id="{AC930200-4F53-4E12-BAB6-62956348303A}" type="datetimeFigureOut">
              <a:rPr lang="zh-CN" altLang="en-US" smtClean="0"/>
              <a:t>2023/9/8</a:t>
            </a:fld>
            <a:endParaRPr lang="zh-CN" altLang="en-US"/>
          </a:p>
        </p:txBody>
      </p:sp>
      <p:sp>
        <p:nvSpPr>
          <p:cNvPr id="8" name="页脚占位符 7">
            <a:extLst>
              <a:ext uri="{FF2B5EF4-FFF2-40B4-BE49-F238E27FC236}">
                <a16:creationId xmlns:a16="http://schemas.microsoft.com/office/drawing/2014/main" id="{691C1BAA-D94D-99B8-9DEB-265B89CBCC98}"/>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A5890A4B-7CFD-1FAC-8288-B9D71FFC41D0}"/>
              </a:ext>
            </a:extLst>
          </p:cNvPr>
          <p:cNvSpPr>
            <a:spLocks noGrp="1"/>
          </p:cNvSpPr>
          <p:nvPr>
            <p:ph type="sldNum" sz="quarter" idx="12"/>
          </p:nvPr>
        </p:nvSpPr>
        <p:spPr/>
        <p:txBody>
          <a:body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19030079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766513D-4296-135C-D315-1EB380355878}"/>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300FE5DE-A2F7-4244-CF3B-98F312BA6684}"/>
              </a:ext>
            </a:extLst>
          </p:cNvPr>
          <p:cNvSpPr>
            <a:spLocks noGrp="1"/>
          </p:cNvSpPr>
          <p:nvPr>
            <p:ph type="dt" sz="half" idx="10"/>
          </p:nvPr>
        </p:nvSpPr>
        <p:spPr/>
        <p:txBody>
          <a:bodyPr/>
          <a:lstStyle/>
          <a:p>
            <a:fld id="{AC930200-4F53-4E12-BAB6-62956348303A}" type="datetimeFigureOut">
              <a:rPr lang="zh-CN" altLang="en-US" smtClean="0"/>
              <a:t>2023/9/8</a:t>
            </a:fld>
            <a:endParaRPr lang="zh-CN" altLang="en-US"/>
          </a:p>
        </p:txBody>
      </p:sp>
      <p:sp>
        <p:nvSpPr>
          <p:cNvPr id="4" name="页脚占位符 3">
            <a:extLst>
              <a:ext uri="{FF2B5EF4-FFF2-40B4-BE49-F238E27FC236}">
                <a16:creationId xmlns:a16="http://schemas.microsoft.com/office/drawing/2014/main" id="{057F0CDB-0366-0FD5-16F0-4B9A74307C0A}"/>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67F7083B-60D1-1BA5-89E8-8FBE6AAAB7D5}"/>
              </a:ext>
            </a:extLst>
          </p:cNvPr>
          <p:cNvSpPr>
            <a:spLocks noGrp="1"/>
          </p:cNvSpPr>
          <p:nvPr>
            <p:ph type="sldNum" sz="quarter" idx="12"/>
          </p:nvPr>
        </p:nvSpPr>
        <p:spPr/>
        <p:txBody>
          <a:body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15691269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52EB7CEE-3C77-6AAA-785D-E711ECB06C58}"/>
              </a:ext>
            </a:extLst>
          </p:cNvPr>
          <p:cNvSpPr>
            <a:spLocks noGrp="1"/>
          </p:cNvSpPr>
          <p:nvPr>
            <p:ph type="dt" sz="half" idx="10"/>
          </p:nvPr>
        </p:nvSpPr>
        <p:spPr/>
        <p:txBody>
          <a:bodyPr/>
          <a:lstStyle/>
          <a:p>
            <a:fld id="{AC930200-4F53-4E12-BAB6-62956348303A}" type="datetimeFigureOut">
              <a:rPr lang="zh-CN" altLang="en-US" smtClean="0"/>
              <a:t>2023/9/8</a:t>
            </a:fld>
            <a:endParaRPr lang="zh-CN" altLang="en-US"/>
          </a:p>
        </p:txBody>
      </p:sp>
      <p:sp>
        <p:nvSpPr>
          <p:cNvPr id="3" name="页脚占位符 2">
            <a:extLst>
              <a:ext uri="{FF2B5EF4-FFF2-40B4-BE49-F238E27FC236}">
                <a16:creationId xmlns:a16="http://schemas.microsoft.com/office/drawing/2014/main" id="{54FD4331-212A-6B53-2086-1515D643FF01}"/>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705EBD6B-47FC-DC1B-917B-25E2AE3D0BE2}"/>
              </a:ext>
            </a:extLst>
          </p:cNvPr>
          <p:cNvSpPr>
            <a:spLocks noGrp="1"/>
          </p:cNvSpPr>
          <p:nvPr>
            <p:ph type="sldNum" sz="quarter" idx="12"/>
          </p:nvPr>
        </p:nvSpPr>
        <p:spPr/>
        <p:txBody>
          <a:body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21944558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3B8FB9E-8433-0141-27BE-850EDE052567}"/>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F5DA51B6-CAB9-C80C-1C44-B9A680AE0E2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DB422F13-E63D-CD32-3B19-8321282C3FD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70F2F621-C117-F5DB-A18C-CDAA670C5386}"/>
              </a:ext>
            </a:extLst>
          </p:cNvPr>
          <p:cNvSpPr>
            <a:spLocks noGrp="1"/>
          </p:cNvSpPr>
          <p:nvPr>
            <p:ph type="dt" sz="half" idx="10"/>
          </p:nvPr>
        </p:nvSpPr>
        <p:spPr/>
        <p:txBody>
          <a:bodyPr/>
          <a:lstStyle/>
          <a:p>
            <a:fld id="{AC930200-4F53-4E12-BAB6-62956348303A}" type="datetimeFigureOut">
              <a:rPr lang="zh-CN" altLang="en-US" smtClean="0"/>
              <a:t>2023/9/8</a:t>
            </a:fld>
            <a:endParaRPr lang="zh-CN" altLang="en-US"/>
          </a:p>
        </p:txBody>
      </p:sp>
      <p:sp>
        <p:nvSpPr>
          <p:cNvPr id="6" name="页脚占位符 5">
            <a:extLst>
              <a:ext uri="{FF2B5EF4-FFF2-40B4-BE49-F238E27FC236}">
                <a16:creationId xmlns:a16="http://schemas.microsoft.com/office/drawing/2014/main" id="{6FE1AFCE-1731-7825-5B0C-5052AEF6A6D1}"/>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209FE947-EB67-6ACF-1C75-E42EED8E9453}"/>
              </a:ext>
            </a:extLst>
          </p:cNvPr>
          <p:cNvSpPr>
            <a:spLocks noGrp="1"/>
          </p:cNvSpPr>
          <p:nvPr>
            <p:ph type="sldNum" sz="quarter" idx="12"/>
          </p:nvPr>
        </p:nvSpPr>
        <p:spPr/>
        <p:txBody>
          <a:body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18084443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8E0C000-0345-3F95-C47A-32D0594BE7F9}"/>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FF4D6656-8C16-CA70-EEEE-514CD6D6ED0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95771E7B-7A8F-E01B-585D-FE5BB2FFF11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F0ADBE23-A2B1-1E27-C3B8-04A2B9C0D040}"/>
              </a:ext>
            </a:extLst>
          </p:cNvPr>
          <p:cNvSpPr>
            <a:spLocks noGrp="1"/>
          </p:cNvSpPr>
          <p:nvPr>
            <p:ph type="dt" sz="half" idx="10"/>
          </p:nvPr>
        </p:nvSpPr>
        <p:spPr/>
        <p:txBody>
          <a:bodyPr/>
          <a:lstStyle/>
          <a:p>
            <a:fld id="{AC930200-4F53-4E12-BAB6-62956348303A}" type="datetimeFigureOut">
              <a:rPr lang="zh-CN" altLang="en-US" smtClean="0"/>
              <a:t>2023/9/8</a:t>
            </a:fld>
            <a:endParaRPr lang="zh-CN" altLang="en-US"/>
          </a:p>
        </p:txBody>
      </p:sp>
      <p:sp>
        <p:nvSpPr>
          <p:cNvPr id="6" name="页脚占位符 5">
            <a:extLst>
              <a:ext uri="{FF2B5EF4-FFF2-40B4-BE49-F238E27FC236}">
                <a16:creationId xmlns:a16="http://schemas.microsoft.com/office/drawing/2014/main" id="{A480FDB1-4B9A-8EA2-8E57-25EB2144C20D}"/>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BF67D1EA-611F-5807-08D2-1D3818EA32A6}"/>
              </a:ext>
            </a:extLst>
          </p:cNvPr>
          <p:cNvSpPr>
            <a:spLocks noGrp="1"/>
          </p:cNvSpPr>
          <p:nvPr>
            <p:ph type="sldNum" sz="quarter" idx="12"/>
          </p:nvPr>
        </p:nvSpPr>
        <p:spPr/>
        <p:txBody>
          <a:body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29445294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55AADAC9-8B97-D694-1E5D-6C494635F38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B2F572A8-3173-46B3-01AD-308E05ED13C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74A52BA2-ED87-4D60-B8F8-9798C1A031B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C930200-4F53-4E12-BAB6-62956348303A}" type="datetimeFigureOut">
              <a:rPr lang="zh-CN" altLang="en-US" smtClean="0"/>
              <a:t>2023/9/8</a:t>
            </a:fld>
            <a:endParaRPr lang="zh-CN" altLang="en-US"/>
          </a:p>
        </p:txBody>
      </p:sp>
      <p:sp>
        <p:nvSpPr>
          <p:cNvPr id="5" name="页脚占位符 4">
            <a:extLst>
              <a:ext uri="{FF2B5EF4-FFF2-40B4-BE49-F238E27FC236}">
                <a16:creationId xmlns:a16="http://schemas.microsoft.com/office/drawing/2014/main" id="{B2432A81-0525-CBF3-A973-A22C3E752D3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AD86CA7D-5976-7FA2-46CC-6F6BD5C9012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5E1432B-3EA4-4264-BA29-68799808BACD}" type="slidenum">
              <a:rPr lang="zh-CN" altLang="en-US" smtClean="0"/>
              <a:t>‹#›</a:t>
            </a:fld>
            <a:endParaRPr lang="zh-CN" altLang="en-US"/>
          </a:p>
        </p:txBody>
      </p:sp>
    </p:spTree>
    <p:extLst>
      <p:ext uri="{BB962C8B-B14F-4D97-AF65-F5344CB8AC3E}">
        <p14:creationId xmlns:p14="http://schemas.microsoft.com/office/powerpoint/2010/main" val="182291331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图表 1">
            <a:extLst>
              <a:ext uri="{FF2B5EF4-FFF2-40B4-BE49-F238E27FC236}">
                <a16:creationId xmlns:a16="http://schemas.microsoft.com/office/drawing/2014/main" id="{FCD45DDC-219B-12CC-31A1-462AE8533B65}"/>
              </a:ext>
            </a:extLst>
          </p:cNvPr>
          <p:cNvGraphicFramePr>
            <a:graphicFrameLocks/>
          </p:cNvGraphicFramePr>
          <p:nvPr>
            <p:extLst>
              <p:ext uri="{D42A27DB-BD31-4B8C-83A1-F6EECF244321}">
                <p14:modId xmlns:p14="http://schemas.microsoft.com/office/powerpoint/2010/main" val="1443282815"/>
              </p:ext>
            </p:extLst>
          </p:nvPr>
        </p:nvGraphicFramePr>
        <p:xfrm>
          <a:off x="2068830" y="1073208"/>
          <a:ext cx="8054340" cy="3448050"/>
        </p:xfrm>
        <a:graphic>
          <a:graphicData uri="http://schemas.openxmlformats.org/drawingml/2006/chart">
            <c:chart xmlns:c="http://schemas.openxmlformats.org/drawingml/2006/chart" xmlns:r="http://schemas.openxmlformats.org/officeDocument/2006/relationships" r:id="rId3"/>
          </a:graphicData>
        </a:graphic>
      </p:graphicFrame>
      <p:sp>
        <p:nvSpPr>
          <p:cNvPr id="4" name="文本框 3">
            <a:extLst>
              <a:ext uri="{FF2B5EF4-FFF2-40B4-BE49-F238E27FC236}">
                <a16:creationId xmlns:a16="http://schemas.microsoft.com/office/drawing/2014/main" id="{C8C4793D-1681-45EE-7EA3-DC23D6733167}"/>
              </a:ext>
            </a:extLst>
          </p:cNvPr>
          <p:cNvSpPr txBox="1"/>
          <p:nvPr/>
        </p:nvSpPr>
        <p:spPr>
          <a:xfrm>
            <a:off x="1730779" y="4607620"/>
            <a:ext cx="9283584" cy="2031325"/>
          </a:xfrm>
          <a:prstGeom prst="rect">
            <a:avLst/>
          </a:prstGeom>
          <a:noFill/>
        </p:spPr>
        <p:txBody>
          <a:bodyPr wrap="square">
            <a:spAutoFit/>
          </a:bodyPr>
          <a:lstStyle/>
          <a:p>
            <a:r>
              <a:rPr lang="en-US" altLang="zh-CN" b="1" dirty="0"/>
              <a:t>Figure S1. The influence of sequencing depth on genotyping. As expected, the number of called SNVs (SNVs with read depth&lt;5, or&gt; (arg+4s.d.)-fold have been excluded) increased together with increased sequencing depths. The number of AAB allele (SNVs with low VAF) was more abundant and remarkably influenced by sequencing depth, therefore, they are excluded from our statistical model. On the other hand, the number of other allele types (</a:t>
            </a:r>
            <a:r>
              <a:rPr lang="de-DE" altLang="zh-CN" b="1" dirty="0"/>
              <a:t>i.e., AB, B, and ABB</a:t>
            </a:r>
            <a:r>
              <a:rPr lang="en-US" altLang="zh-CN" b="1" dirty="0"/>
              <a:t>) were less affected by sequencing depth and could potentially be used as signals for AOH detection. </a:t>
            </a:r>
            <a:endParaRPr lang="zh-CN" altLang="en-US" b="1" dirty="0"/>
          </a:p>
        </p:txBody>
      </p:sp>
    </p:spTree>
    <p:extLst>
      <p:ext uri="{BB962C8B-B14F-4D97-AF65-F5344CB8AC3E}">
        <p14:creationId xmlns:p14="http://schemas.microsoft.com/office/powerpoint/2010/main" val="7224771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utoShape 2">
            <a:extLst>
              <a:ext uri="{FF2B5EF4-FFF2-40B4-BE49-F238E27FC236}">
                <a16:creationId xmlns:a16="http://schemas.microsoft.com/office/drawing/2014/main" id="{60A1EA20-C6C1-37C9-5E37-D5E2EA786AF9}"/>
              </a:ext>
            </a:extLst>
          </p:cNvPr>
          <p:cNvSpPr>
            <a:spLocks noChangeAspect="1" noChangeArrowheads="1"/>
          </p:cNvSpPr>
          <p:nvPr/>
        </p:nvSpPr>
        <p:spPr bwMode="auto">
          <a:xfrm>
            <a:off x="5943600" y="327660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 name="文本框 6">
            <a:extLst>
              <a:ext uri="{FF2B5EF4-FFF2-40B4-BE49-F238E27FC236}">
                <a16:creationId xmlns:a16="http://schemas.microsoft.com/office/drawing/2014/main" id="{9D80BC57-4F23-2D36-1A12-C9FE58E9B0D6}"/>
              </a:ext>
            </a:extLst>
          </p:cNvPr>
          <p:cNvSpPr txBox="1"/>
          <p:nvPr/>
        </p:nvSpPr>
        <p:spPr>
          <a:xfrm>
            <a:off x="9205788" y="4335547"/>
            <a:ext cx="2766079" cy="1477328"/>
          </a:xfrm>
          <a:prstGeom prst="rect">
            <a:avLst/>
          </a:prstGeom>
          <a:noFill/>
        </p:spPr>
        <p:txBody>
          <a:bodyPr wrap="square" rtlCol="0">
            <a:spAutoFit/>
          </a:bodyPr>
          <a:lstStyle/>
          <a:p>
            <a:r>
              <a:rPr lang="en-US" altLang="zh-CN" b="1" dirty="0"/>
              <a:t>Figure S2. The possibility of CNV, aneuploidy and polyploidy had been ruled out by log2 Ratio figure of CMA-seq.</a:t>
            </a:r>
            <a:endParaRPr lang="zh-CN" altLang="en-US" b="1" dirty="0"/>
          </a:p>
        </p:txBody>
      </p:sp>
      <p:grpSp>
        <p:nvGrpSpPr>
          <p:cNvPr id="10" name="组合 9">
            <a:extLst>
              <a:ext uri="{FF2B5EF4-FFF2-40B4-BE49-F238E27FC236}">
                <a16:creationId xmlns:a16="http://schemas.microsoft.com/office/drawing/2014/main" id="{0DFAAFB9-776F-D37D-FF01-7D14DE8305AD}"/>
              </a:ext>
            </a:extLst>
          </p:cNvPr>
          <p:cNvGrpSpPr/>
          <p:nvPr/>
        </p:nvGrpSpPr>
        <p:grpSpPr>
          <a:xfrm>
            <a:off x="207592" y="224653"/>
            <a:ext cx="9006509" cy="6475886"/>
            <a:chOff x="207592" y="224653"/>
            <a:chExt cx="9006509" cy="6475886"/>
          </a:xfrm>
        </p:grpSpPr>
        <p:pic>
          <p:nvPicPr>
            <p:cNvPr id="4" name="图片 3">
              <a:extLst>
                <a:ext uri="{FF2B5EF4-FFF2-40B4-BE49-F238E27FC236}">
                  <a16:creationId xmlns:a16="http://schemas.microsoft.com/office/drawing/2014/main" id="{D2D2DAC7-E694-705A-1F67-AA19FBA310D9}"/>
                </a:ext>
              </a:extLst>
            </p:cNvPr>
            <p:cNvPicPr>
              <a:picLocks noChangeAspect="1"/>
            </p:cNvPicPr>
            <p:nvPr/>
          </p:nvPicPr>
          <p:blipFill>
            <a:blip r:embed="rId2"/>
            <a:stretch>
              <a:fillRect/>
            </a:stretch>
          </p:blipFill>
          <p:spPr>
            <a:xfrm>
              <a:off x="668616" y="224653"/>
              <a:ext cx="8537172" cy="2276579"/>
            </a:xfrm>
            <a:prstGeom prst="rect">
              <a:avLst/>
            </a:prstGeom>
          </p:spPr>
        </p:pic>
        <p:pic>
          <p:nvPicPr>
            <p:cNvPr id="5" name="图片 4">
              <a:extLst>
                <a:ext uri="{FF2B5EF4-FFF2-40B4-BE49-F238E27FC236}">
                  <a16:creationId xmlns:a16="http://schemas.microsoft.com/office/drawing/2014/main" id="{96C9078A-8550-7EB0-36B7-DDC0609B4646}"/>
                </a:ext>
              </a:extLst>
            </p:cNvPr>
            <p:cNvPicPr>
              <a:picLocks noChangeAspect="1"/>
            </p:cNvPicPr>
            <p:nvPr/>
          </p:nvPicPr>
          <p:blipFill>
            <a:blip r:embed="rId3"/>
            <a:stretch>
              <a:fillRect/>
            </a:stretch>
          </p:blipFill>
          <p:spPr>
            <a:xfrm>
              <a:off x="676929" y="2290711"/>
              <a:ext cx="8537172" cy="2276579"/>
            </a:xfrm>
            <a:prstGeom prst="rect">
              <a:avLst/>
            </a:prstGeom>
          </p:spPr>
        </p:pic>
        <p:pic>
          <p:nvPicPr>
            <p:cNvPr id="6" name="图片 5">
              <a:extLst>
                <a:ext uri="{FF2B5EF4-FFF2-40B4-BE49-F238E27FC236}">
                  <a16:creationId xmlns:a16="http://schemas.microsoft.com/office/drawing/2014/main" id="{3B3F35F6-8631-9987-75D2-A86F49D8E7F2}"/>
                </a:ext>
              </a:extLst>
            </p:cNvPr>
            <p:cNvPicPr>
              <a:picLocks noChangeAspect="1"/>
            </p:cNvPicPr>
            <p:nvPr/>
          </p:nvPicPr>
          <p:blipFill>
            <a:blip r:embed="rId4"/>
            <a:stretch>
              <a:fillRect/>
            </a:stretch>
          </p:blipFill>
          <p:spPr>
            <a:xfrm>
              <a:off x="676929" y="4439896"/>
              <a:ext cx="8477410" cy="2260643"/>
            </a:xfrm>
            <a:prstGeom prst="rect">
              <a:avLst/>
            </a:prstGeom>
          </p:spPr>
        </p:pic>
        <p:sp>
          <p:nvSpPr>
            <p:cNvPr id="3" name="文本框 2">
              <a:extLst>
                <a:ext uri="{FF2B5EF4-FFF2-40B4-BE49-F238E27FC236}">
                  <a16:creationId xmlns:a16="http://schemas.microsoft.com/office/drawing/2014/main" id="{F029CE08-780F-B69E-A45C-1A85241A8DCE}"/>
                </a:ext>
              </a:extLst>
            </p:cNvPr>
            <p:cNvSpPr txBox="1"/>
            <p:nvPr/>
          </p:nvSpPr>
          <p:spPr>
            <a:xfrm>
              <a:off x="207592" y="1136713"/>
              <a:ext cx="1127232" cy="369332"/>
            </a:xfrm>
            <a:prstGeom prst="rect">
              <a:avLst/>
            </a:prstGeom>
            <a:noFill/>
          </p:spPr>
          <p:txBody>
            <a:bodyPr wrap="none" rtlCol="0">
              <a:spAutoFit/>
            </a:bodyPr>
            <a:lstStyle/>
            <a:p>
              <a:r>
                <a:rPr lang="en-US" altLang="zh-CN" b="1" dirty="0"/>
                <a:t>Case #28</a:t>
              </a:r>
              <a:endParaRPr lang="zh-CN" altLang="en-US" b="1" dirty="0"/>
            </a:p>
          </p:txBody>
        </p:sp>
        <p:sp>
          <p:nvSpPr>
            <p:cNvPr id="8" name="文本框 7">
              <a:extLst>
                <a:ext uri="{FF2B5EF4-FFF2-40B4-BE49-F238E27FC236}">
                  <a16:creationId xmlns:a16="http://schemas.microsoft.com/office/drawing/2014/main" id="{86014BE2-55B7-7636-E249-2C6FFBD2971D}"/>
                </a:ext>
              </a:extLst>
            </p:cNvPr>
            <p:cNvSpPr txBox="1"/>
            <p:nvPr/>
          </p:nvSpPr>
          <p:spPr>
            <a:xfrm>
              <a:off x="207592" y="3019797"/>
              <a:ext cx="1127232" cy="369332"/>
            </a:xfrm>
            <a:prstGeom prst="rect">
              <a:avLst/>
            </a:prstGeom>
            <a:noFill/>
          </p:spPr>
          <p:txBody>
            <a:bodyPr wrap="none" rtlCol="0">
              <a:spAutoFit/>
            </a:bodyPr>
            <a:lstStyle/>
            <a:p>
              <a:r>
                <a:rPr lang="en-US" altLang="zh-CN" b="1" dirty="0"/>
                <a:t>Case #60</a:t>
              </a:r>
              <a:endParaRPr lang="zh-CN" altLang="en-US" b="1" dirty="0"/>
            </a:p>
          </p:txBody>
        </p:sp>
        <p:sp>
          <p:nvSpPr>
            <p:cNvPr id="9" name="文本框 8">
              <a:extLst>
                <a:ext uri="{FF2B5EF4-FFF2-40B4-BE49-F238E27FC236}">
                  <a16:creationId xmlns:a16="http://schemas.microsoft.com/office/drawing/2014/main" id="{D0AFADB4-6431-879D-58BE-42FC764993BE}"/>
                </a:ext>
              </a:extLst>
            </p:cNvPr>
            <p:cNvSpPr txBox="1"/>
            <p:nvPr/>
          </p:nvSpPr>
          <p:spPr>
            <a:xfrm>
              <a:off x="211190" y="5056454"/>
              <a:ext cx="1127232" cy="369332"/>
            </a:xfrm>
            <a:prstGeom prst="rect">
              <a:avLst/>
            </a:prstGeom>
            <a:noFill/>
          </p:spPr>
          <p:txBody>
            <a:bodyPr wrap="none" rtlCol="0">
              <a:spAutoFit/>
            </a:bodyPr>
            <a:lstStyle/>
            <a:p>
              <a:r>
                <a:rPr lang="en-US" altLang="zh-CN" b="1" dirty="0"/>
                <a:t>Case #63</a:t>
              </a:r>
              <a:endParaRPr lang="zh-CN" altLang="en-US" b="1" dirty="0"/>
            </a:p>
          </p:txBody>
        </p:sp>
      </p:grpSp>
    </p:spTree>
    <p:extLst>
      <p:ext uri="{BB962C8B-B14F-4D97-AF65-F5344CB8AC3E}">
        <p14:creationId xmlns:p14="http://schemas.microsoft.com/office/powerpoint/2010/main" val="10367989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8861691F-C380-4172-9C08-F28383F0F454}"/>
              </a:ext>
            </a:extLst>
          </p:cNvPr>
          <p:cNvSpPr txBox="1"/>
          <p:nvPr/>
        </p:nvSpPr>
        <p:spPr>
          <a:xfrm>
            <a:off x="2250937" y="5551258"/>
            <a:ext cx="7709361" cy="923330"/>
          </a:xfrm>
          <a:prstGeom prst="rect">
            <a:avLst/>
          </a:prstGeom>
          <a:noFill/>
        </p:spPr>
        <p:txBody>
          <a:bodyPr wrap="square">
            <a:spAutoFit/>
          </a:bodyPr>
          <a:lstStyle/>
          <a:p>
            <a:r>
              <a:rPr lang="en-US" altLang="zh-CN" b="1" dirty="0"/>
              <a:t>Figure S3. (A) showed the bona fide mosaic AOH, (B, C, D) showed the scenarios of spurious mosaic AOH. Red line indicated the </a:t>
            </a:r>
            <a:r>
              <a:rPr lang="en-US" altLang="zh-CN" b="1" dirty="0" err="1"/>
              <a:t>AB_count_Z_score</a:t>
            </a:r>
            <a:r>
              <a:rPr lang="en-US" altLang="zh-CN" b="1" dirty="0"/>
              <a:t>, orange line indicated the </a:t>
            </a:r>
            <a:r>
              <a:rPr lang="en-US" altLang="zh-CN" b="1" dirty="0" err="1"/>
              <a:t>ABB_count_Z_score</a:t>
            </a:r>
            <a:r>
              <a:rPr lang="en-US" altLang="zh-CN" b="1" dirty="0"/>
              <a:t>. </a:t>
            </a:r>
            <a:endParaRPr lang="zh-CN" altLang="en-US" b="1" dirty="0"/>
          </a:p>
        </p:txBody>
      </p:sp>
      <p:grpSp>
        <p:nvGrpSpPr>
          <p:cNvPr id="8" name="组合 7">
            <a:extLst>
              <a:ext uri="{FF2B5EF4-FFF2-40B4-BE49-F238E27FC236}">
                <a16:creationId xmlns:a16="http://schemas.microsoft.com/office/drawing/2014/main" id="{5C649065-84AB-51F4-E551-5BF3C4ABA188}"/>
              </a:ext>
            </a:extLst>
          </p:cNvPr>
          <p:cNvGrpSpPr/>
          <p:nvPr/>
        </p:nvGrpSpPr>
        <p:grpSpPr>
          <a:xfrm>
            <a:off x="2252749" y="294919"/>
            <a:ext cx="6243551" cy="5091468"/>
            <a:chOff x="2252749" y="294919"/>
            <a:chExt cx="6243551" cy="5091468"/>
          </a:xfrm>
        </p:grpSpPr>
        <p:pic>
          <p:nvPicPr>
            <p:cNvPr id="4" name="图片 3">
              <a:extLst>
                <a:ext uri="{FF2B5EF4-FFF2-40B4-BE49-F238E27FC236}">
                  <a16:creationId xmlns:a16="http://schemas.microsoft.com/office/drawing/2014/main" id="{6C0E52D8-1C83-A2F8-86F3-3D9C160E147D}"/>
                </a:ext>
              </a:extLst>
            </p:cNvPr>
            <p:cNvPicPr>
              <a:picLocks noChangeAspect="1"/>
            </p:cNvPicPr>
            <p:nvPr/>
          </p:nvPicPr>
          <p:blipFill>
            <a:blip r:embed="rId2"/>
            <a:stretch>
              <a:fillRect/>
            </a:stretch>
          </p:blipFill>
          <p:spPr>
            <a:xfrm>
              <a:off x="2252749" y="294920"/>
              <a:ext cx="6243551" cy="5091467"/>
            </a:xfrm>
            <a:prstGeom prst="rect">
              <a:avLst/>
            </a:prstGeom>
          </p:spPr>
        </p:pic>
        <p:sp>
          <p:nvSpPr>
            <p:cNvPr id="2" name="文本框 1">
              <a:extLst>
                <a:ext uri="{FF2B5EF4-FFF2-40B4-BE49-F238E27FC236}">
                  <a16:creationId xmlns:a16="http://schemas.microsoft.com/office/drawing/2014/main" id="{8885FFD5-7E81-3EC5-38F6-1333F2A642C4}"/>
                </a:ext>
              </a:extLst>
            </p:cNvPr>
            <p:cNvSpPr txBox="1"/>
            <p:nvPr/>
          </p:nvSpPr>
          <p:spPr>
            <a:xfrm>
              <a:off x="2252749" y="294919"/>
              <a:ext cx="340158" cy="369332"/>
            </a:xfrm>
            <a:prstGeom prst="rect">
              <a:avLst/>
            </a:prstGeom>
            <a:noFill/>
          </p:spPr>
          <p:txBody>
            <a:bodyPr wrap="none" rtlCol="0">
              <a:spAutoFit/>
            </a:bodyPr>
            <a:lstStyle/>
            <a:p>
              <a:r>
                <a:rPr lang="en-US" altLang="zh-CN" b="1" dirty="0"/>
                <a:t>A</a:t>
              </a:r>
              <a:endParaRPr lang="zh-CN" altLang="en-US" b="1" dirty="0"/>
            </a:p>
          </p:txBody>
        </p:sp>
        <p:sp>
          <p:nvSpPr>
            <p:cNvPr id="3" name="文本框 2">
              <a:extLst>
                <a:ext uri="{FF2B5EF4-FFF2-40B4-BE49-F238E27FC236}">
                  <a16:creationId xmlns:a16="http://schemas.microsoft.com/office/drawing/2014/main" id="{3202EF15-45C5-58DF-11FF-EEAE2BA21EFA}"/>
                </a:ext>
              </a:extLst>
            </p:cNvPr>
            <p:cNvSpPr txBox="1"/>
            <p:nvPr/>
          </p:nvSpPr>
          <p:spPr>
            <a:xfrm>
              <a:off x="2252749" y="2840653"/>
              <a:ext cx="327334" cy="369332"/>
            </a:xfrm>
            <a:prstGeom prst="rect">
              <a:avLst/>
            </a:prstGeom>
            <a:noFill/>
          </p:spPr>
          <p:txBody>
            <a:bodyPr wrap="none" rtlCol="0">
              <a:spAutoFit/>
            </a:bodyPr>
            <a:lstStyle/>
            <a:p>
              <a:r>
                <a:rPr lang="en-US" altLang="zh-CN" b="1" dirty="0"/>
                <a:t>C</a:t>
              </a:r>
              <a:endParaRPr lang="zh-CN" altLang="en-US" b="1" dirty="0"/>
            </a:p>
          </p:txBody>
        </p:sp>
        <p:sp>
          <p:nvSpPr>
            <p:cNvPr id="6" name="文本框 5">
              <a:extLst>
                <a:ext uri="{FF2B5EF4-FFF2-40B4-BE49-F238E27FC236}">
                  <a16:creationId xmlns:a16="http://schemas.microsoft.com/office/drawing/2014/main" id="{6891E242-8A3B-D3F6-E137-E5E1B9DD07FE}"/>
                </a:ext>
              </a:extLst>
            </p:cNvPr>
            <p:cNvSpPr txBox="1"/>
            <p:nvPr/>
          </p:nvSpPr>
          <p:spPr>
            <a:xfrm>
              <a:off x="5772122" y="294919"/>
              <a:ext cx="324128" cy="369332"/>
            </a:xfrm>
            <a:prstGeom prst="rect">
              <a:avLst/>
            </a:prstGeom>
            <a:noFill/>
          </p:spPr>
          <p:txBody>
            <a:bodyPr wrap="none" rtlCol="0">
              <a:spAutoFit/>
            </a:bodyPr>
            <a:lstStyle/>
            <a:p>
              <a:r>
                <a:rPr lang="en-US" altLang="zh-CN" b="1" dirty="0"/>
                <a:t>B</a:t>
              </a:r>
              <a:endParaRPr lang="zh-CN" altLang="en-US" b="1" dirty="0"/>
            </a:p>
          </p:txBody>
        </p:sp>
        <p:sp>
          <p:nvSpPr>
            <p:cNvPr id="7" name="文本框 6">
              <a:extLst>
                <a:ext uri="{FF2B5EF4-FFF2-40B4-BE49-F238E27FC236}">
                  <a16:creationId xmlns:a16="http://schemas.microsoft.com/office/drawing/2014/main" id="{8BF8D07C-652E-1345-A7A1-83B445CEA45F}"/>
                </a:ext>
              </a:extLst>
            </p:cNvPr>
            <p:cNvSpPr txBox="1"/>
            <p:nvPr/>
          </p:nvSpPr>
          <p:spPr>
            <a:xfrm>
              <a:off x="5755842" y="2840653"/>
              <a:ext cx="349776" cy="369332"/>
            </a:xfrm>
            <a:prstGeom prst="rect">
              <a:avLst/>
            </a:prstGeom>
            <a:noFill/>
          </p:spPr>
          <p:txBody>
            <a:bodyPr wrap="none" rtlCol="0">
              <a:spAutoFit/>
            </a:bodyPr>
            <a:lstStyle/>
            <a:p>
              <a:r>
                <a:rPr lang="en-US" altLang="zh-CN" b="1" dirty="0"/>
                <a:t>D</a:t>
              </a:r>
              <a:endParaRPr lang="zh-CN" altLang="en-US" b="1" dirty="0"/>
            </a:p>
          </p:txBody>
        </p:sp>
      </p:grpSp>
    </p:spTree>
    <p:extLst>
      <p:ext uri="{BB962C8B-B14F-4D97-AF65-F5344CB8AC3E}">
        <p14:creationId xmlns:p14="http://schemas.microsoft.com/office/powerpoint/2010/main" val="14941932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4069C4F9-9B2D-806E-0E6E-6E50E108A294}"/>
              </a:ext>
            </a:extLst>
          </p:cNvPr>
          <p:cNvSpPr txBox="1"/>
          <p:nvPr/>
        </p:nvSpPr>
        <p:spPr>
          <a:xfrm>
            <a:off x="1197032" y="5453871"/>
            <a:ext cx="10440786" cy="646331"/>
          </a:xfrm>
          <a:prstGeom prst="rect">
            <a:avLst/>
          </a:prstGeom>
          <a:noFill/>
        </p:spPr>
        <p:txBody>
          <a:bodyPr wrap="square">
            <a:spAutoFit/>
          </a:bodyPr>
          <a:lstStyle/>
          <a:p>
            <a:r>
              <a:rPr lang="en-US" altLang="zh-CN" b="1" dirty="0"/>
              <a:t>Figure S4. The D1</a:t>
            </a:r>
            <a:r>
              <a:rPr lang="el-GR" altLang="zh-CN" b="1" dirty="0"/>
              <a:t> </a:t>
            </a:r>
            <a:r>
              <a:rPr lang="en-US" altLang="zh-CN" b="1" dirty="0"/>
              <a:t>plot and D</a:t>
            </a:r>
            <a:r>
              <a:rPr lang="el-GR" altLang="zh-CN" b="1" dirty="0"/>
              <a:t>2 </a:t>
            </a:r>
            <a:r>
              <a:rPr lang="en-US" altLang="zh-CN" b="1" dirty="0"/>
              <a:t>plot of case #170. In this case, one AOH event was detected by CMA but missed by CMA-seq due to the lower D1 value (1.319) of the corresponding AOH region.</a:t>
            </a:r>
            <a:endParaRPr lang="zh-CN" altLang="en-US" b="1" dirty="0"/>
          </a:p>
        </p:txBody>
      </p:sp>
      <p:grpSp>
        <p:nvGrpSpPr>
          <p:cNvPr id="2" name="组合 1">
            <a:extLst>
              <a:ext uri="{FF2B5EF4-FFF2-40B4-BE49-F238E27FC236}">
                <a16:creationId xmlns:a16="http://schemas.microsoft.com/office/drawing/2014/main" id="{87445E3B-AA7C-73F8-3E9A-17564281750F}"/>
              </a:ext>
            </a:extLst>
          </p:cNvPr>
          <p:cNvGrpSpPr/>
          <p:nvPr/>
        </p:nvGrpSpPr>
        <p:grpSpPr>
          <a:xfrm>
            <a:off x="396240" y="545343"/>
            <a:ext cx="11682153" cy="4572309"/>
            <a:chOff x="396240" y="545343"/>
            <a:chExt cx="11682153" cy="4572309"/>
          </a:xfrm>
        </p:grpSpPr>
        <p:pic>
          <p:nvPicPr>
            <p:cNvPr id="5" name="图片 4">
              <a:extLst>
                <a:ext uri="{FF2B5EF4-FFF2-40B4-BE49-F238E27FC236}">
                  <a16:creationId xmlns:a16="http://schemas.microsoft.com/office/drawing/2014/main" id="{BA97F7F5-437C-6F33-3028-118F5D1F7065}"/>
                </a:ext>
              </a:extLst>
            </p:cNvPr>
            <p:cNvPicPr>
              <a:picLocks noChangeAspect="1"/>
            </p:cNvPicPr>
            <p:nvPr/>
          </p:nvPicPr>
          <p:blipFill>
            <a:blip r:embed="rId2"/>
            <a:stretch>
              <a:fillRect/>
            </a:stretch>
          </p:blipFill>
          <p:spPr>
            <a:xfrm>
              <a:off x="396240" y="545652"/>
              <a:ext cx="6096000" cy="4572000"/>
            </a:xfrm>
            <a:prstGeom prst="rect">
              <a:avLst/>
            </a:prstGeom>
          </p:spPr>
        </p:pic>
        <p:pic>
          <p:nvPicPr>
            <p:cNvPr id="4" name="图片 3">
              <a:extLst>
                <a:ext uri="{FF2B5EF4-FFF2-40B4-BE49-F238E27FC236}">
                  <a16:creationId xmlns:a16="http://schemas.microsoft.com/office/drawing/2014/main" id="{A1567D55-3099-BB6A-7B25-DDBF00765F60}"/>
                </a:ext>
              </a:extLst>
            </p:cNvPr>
            <p:cNvPicPr>
              <a:picLocks noChangeAspect="1"/>
            </p:cNvPicPr>
            <p:nvPr/>
          </p:nvPicPr>
          <p:blipFill>
            <a:blip r:embed="rId3"/>
            <a:stretch>
              <a:fillRect/>
            </a:stretch>
          </p:blipFill>
          <p:spPr>
            <a:xfrm>
              <a:off x="5982393" y="545343"/>
              <a:ext cx="6096000" cy="4572000"/>
            </a:xfrm>
            <a:prstGeom prst="rect">
              <a:avLst/>
            </a:prstGeom>
          </p:spPr>
        </p:pic>
      </p:grpSp>
      <p:sp>
        <p:nvSpPr>
          <p:cNvPr id="6" name="文本框 5">
            <a:extLst>
              <a:ext uri="{FF2B5EF4-FFF2-40B4-BE49-F238E27FC236}">
                <a16:creationId xmlns:a16="http://schemas.microsoft.com/office/drawing/2014/main" id="{1401FD12-D43F-32C0-26E9-0D5E5527D777}"/>
              </a:ext>
            </a:extLst>
          </p:cNvPr>
          <p:cNvSpPr txBox="1"/>
          <p:nvPr/>
        </p:nvSpPr>
        <p:spPr>
          <a:xfrm>
            <a:off x="4763193" y="1205346"/>
            <a:ext cx="1157689" cy="369332"/>
          </a:xfrm>
          <a:prstGeom prst="rect">
            <a:avLst/>
          </a:prstGeom>
          <a:noFill/>
        </p:spPr>
        <p:txBody>
          <a:bodyPr wrap="none" rtlCol="0">
            <a:spAutoFit/>
          </a:bodyPr>
          <a:lstStyle/>
          <a:p>
            <a:r>
              <a:rPr lang="en-US" altLang="zh-CN" dirty="0"/>
              <a:t>D</a:t>
            </a:r>
            <a:r>
              <a:rPr lang="el-GR" altLang="zh-CN" dirty="0"/>
              <a:t>1</a:t>
            </a:r>
            <a:r>
              <a:rPr lang="en-US" altLang="zh-CN" dirty="0"/>
              <a:t>=1.319</a:t>
            </a:r>
            <a:endParaRPr lang="zh-CN" altLang="en-US" dirty="0"/>
          </a:p>
        </p:txBody>
      </p:sp>
      <p:sp>
        <p:nvSpPr>
          <p:cNvPr id="7" name="文本框 6">
            <a:extLst>
              <a:ext uri="{FF2B5EF4-FFF2-40B4-BE49-F238E27FC236}">
                <a16:creationId xmlns:a16="http://schemas.microsoft.com/office/drawing/2014/main" id="{669E5863-C6BD-E8D6-9075-DBEE42C0E3EA}"/>
              </a:ext>
            </a:extLst>
          </p:cNvPr>
          <p:cNvSpPr txBox="1"/>
          <p:nvPr/>
        </p:nvSpPr>
        <p:spPr>
          <a:xfrm>
            <a:off x="10292371" y="1205346"/>
            <a:ext cx="1157689" cy="369332"/>
          </a:xfrm>
          <a:prstGeom prst="rect">
            <a:avLst/>
          </a:prstGeom>
          <a:noFill/>
        </p:spPr>
        <p:txBody>
          <a:bodyPr wrap="none" rtlCol="0">
            <a:spAutoFit/>
          </a:bodyPr>
          <a:lstStyle/>
          <a:p>
            <a:r>
              <a:rPr lang="en-US" altLang="zh-CN" dirty="0"/>
              <a:t>D2=0.459</a:t>
            </a:r>
            <a:endParaRPr lang="zh-CN" altLang="en-US" dirty="0"/>
          </a:p>
        </p:txBody>
      </p:sp>
    </p:spTree>
    <p:extLst>
      <p:ext uri="{BB962C8B-B14F-4D97-AF65-F5344CB8AC3E}">
        <p14:creationId xmlns:p14="http://schemas.microsoft.com/office/powerpoint/2010/main" val="951210309"/>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60</TotalTime>
  <Words>256</Words>
  <Application>Microsoft Office PowerPoint</Application>
  <PresentationFormat>宽屏</PresentationFormat>
  <Paragraphs>14</Paragraphs>
  <Slides>4</Slides>
  <Notes>1</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4</vt:i4>
      </vt:variant>
    </vt:vector>
  </HeadingPairs>
  <TitlesOfParts>
    <vt:vector size="8" baseType="lpstr">
      <vt:lpstr>等线</vt:lpstr>
      <vt:lpstr>等线 Light</vt:lpstr>
      <vt:lpstr>Arial</vt:lpstr>
      <vt:lpstr>Office 主题​​</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gengniure@126.com</dc:creator>
  <cp:lastModifiedBy>gengniure@126.com</cp:lastModifiedBy>
  <cp:revision>62</cp:revision>
  <dcterms:created xsi:type="dcterms:W3CDTF">2023-07-19T00:33:44Z</dcterms:created>
  <dcterms:modified xsi:type="dcterms:W3CDTF">2023-09-08T06:22:26Z</dcterms:modified>
</cp:coreProperties>
</file>